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79" d="100"/>
          <a:sy n="79" d="100"/>
        </p:scale>
        <p:origin x="-390" y="-7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5B6C2-F7FA-40A5-BB25-E83ED84066D1}" type="datetimeFigureOut">
              <a:rPr lang="en-US" smtClean="0"/>
              <a:pPr/>
              <a:t>6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ECC42-9294-4A98-833D-EAEE95E6E73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83885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5B6C2-F7FA-40A5-BB25-E83ED84066D1}" type="datetimeFigureOut">
              <a:rPr lang="en-US" smtClean="0"/>
              <a:pPr/>
              <a:t>6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ECC42-9294-4A98-833D-EAEE95E6E73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714039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5B6C2-F7FA-40A5-BB25-E83ED84066D1}" type="datetimeFigureOut">
              <a:rPr lang="en-US" smtClean="0"/>
              <a:pPr/>
              <a:t>6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ECC42-9294-4A98-833D-EAEE95E6E73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967815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5B6C2-F7FA-40A5-BB25-E83ED84066D1}" type="datetimeFigureOut">
              <a:rPr lang="en-US" smtClean="0"/>
              <a:pPr/>
              <a:t>6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ECC42-9294-4A98-833D-EAEE95E6E73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971830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5B6C2-F7FA-40A5-BB25-E83ED84066D1}" type="datetimeFigureOut">
              <a:rPr lang="en-US" smtClean="0"/>
              <a:pPr/>
              <a:t>6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ECC42-9294-4A98-833D-EAEE95E6E73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380080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5B6C2-F7FA-40A5-BB25-E83ED84066D1}" type="datetimeFigureOut">
              <a:rPr lang="en-US" smtClean="0"/>
              <a:pPr/>
              <a:t>6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ECC42-9294-4A98-833D-EAEE95E6E73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6569192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5B6C2-F7FA-40A5-BB25-E83ED84066D1}" type="datetimeFigureOut">
              <a:rPr lang="en-US" smtClean="0"/>
              <a:pPr/>
              <a:t>6/2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ECC42-9294-4A98-833D-EAEE95E6E73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1571865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5B6C2-F7FA-40A5-BB25-E83ED84066D1}" type="datetimeFigureOut">
              <a:rPr lang="en-US" smtClean="0"/>
              <a:pPr/>
              <a:t>6/2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ECC42-9294-4A98-833D-EAEE95E6E73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128595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5B6C2-F7FA-40A5-BB25-E83ED84066D1}" type="datetimeFigureOut">
              <a:rPr lang="en-US" smtClean="0"/>
              <a:pPr/>
              <a:t>6/2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ECC42-9294-4A98-833D-EAEE95E6E73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9814373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5B6C2-F7FA-40A5-BB25-E83ED84066D1}" type="datetimeFigureOut">
              <a:rPr lang="en-US" smtClean="0"/>
              <a:pPr/>
              <a:t>6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ECC42-9294-4A98-833D-EAEE95E6E73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1655619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5B6C2-F7FA-40A5-BB25-E83ED84066D1}" type="datetimeFigureOut">
              <a:rPr lang="en-US" smtClean="0"/>
              <a:pPr/>
              <a:t>6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8ECC42-9294-4A98-833D-EAEE95E6E73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5518585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95B6C2-F7FA-40A5-BB25-E83ED84066D1}" type="datetimeFigureOut">
              <a:rPr lang="en-US" smtClean="0"/>
              <a:pPr/>
              <a:t>6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8ECC42-9294-4A98-833D-EAEE95E6E73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8130333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3090332" y="597659"/>
            <a:ext cx="6416675" cy="5762395"/>
          </a:xfrm>
          <a:prstGeom prst="rect">
            <a:avLst/>
          </a:prstGeom>
        </p:spPr>
      </p:pic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511759621"/>
              </p:ext>
            </p:extLst>
          </p:nvPr>
        </p:nvGraphicFramePr>
        <p:xfrm>
          <a:off x="2091266" y="4836054"/>
          <a:ext cx="2235200" cy="1524000"/>
        </p:xfrm>
        <a:graphic>
          <a:graphicData uri="http://schemas.openxmlformats.org/drawingml/2006/table">
            <a:tbl>
              <a:tblPr/>
              <a:tblGrid>
                <a:gridCol w="1065287"/>
                <a:gridCol w="570689"/>
                <a:gridCol w="599224"/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N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videnc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hsa-miR-181d-5p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BCL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B050"/>
                          </a:solidFill>
                          <a:effectLst/>
                          <a:latin typeface="Calibri" panose="020F0502020204030204" pitchFamily="34" charset="0"/>
                        </a:rPr>
                        <a:t>Strong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a-miR-181d-5p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P90B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eak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a-miR-181d-5p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UBB2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eak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a-miR-181d-5p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TLC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eak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a-miR-181d-5p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BL1XR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eak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a-miR-181d-5p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A5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eak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a-miR-181d-5p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Z2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eak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3345720779"/>
              </p:ext>
            </p:extLst>
          </p:nvPr>
        </p:nvGraphicFramePr>
        <p:xfrm>
          <a:off x="8870950" y="2716856"/>
          <a:ext cx="1968500" cy="1524000"/>
        </p:xfrm>
        <a:graphic>
          <a:graphicData uri="http://schemas.openxmlformats.org/drawingml/2006/table">
            <a:tbl>
              <a:tblPr/>
              <a:tblGrid>
                <a:gridCol w="789302"/>
                <a:gridCol w="570580"/>
                <a:gridCol w="608618"/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N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videnc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a-miR-20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CL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eak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a-miR-20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GF1R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eak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a-miR-20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GP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eak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a-miR-20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RS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eak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a-miR-20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K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eak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a-miR-20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P90B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eak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a-miR-20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TLC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eak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963335889"/>
              </p:ext>
            </p:extLst>
          </p:nvPr>
        </p:nvGraphicFramePr>
        <p:xfrm>
          <a:off x="1295400" y="1179777"/>
          <a:ext cx="2235200" cy="1714500"/>
        </p:xfrm>
        <a:graphic>
          <a:graphicData uri="http://schemas.openxmlformats.org/drawingml/2006/table">
            <a:tbl>
              <a:tblPr/>
              <a:tblGrid>
                <a:gridCol w="1065287"/>
                <a:gridCol w="570689"/>
                <a:gridCol w="599224"/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NA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n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videnc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a-miR-625-5p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ERS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eak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a-miR-625-5p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GF1R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eak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a-miR-625-5p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BL1XR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eak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a-miR-625-5p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GP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eak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a-miR-625-5p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Z2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eak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a-miR-625-5p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K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eak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a-miR-625-5p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A5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eak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sa-miR-625-5p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UBB2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eak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0" name="Rectangle 9"/>
          <p:cNvSpPr/>
          <p:nvPr/>
        </p:nvSpPr>
        <p:spPr>
          <a:xfrm>
            <a:off x="275109" y="323334"/>
            <a:ext cx="105253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smtClean="0"/>
              <a:t>Figure </a:t>
            </a:r>
            <a:r>
              <a:rPr lang="en-US" b="1" dirty="0" err="1" smtClean="0"/>
              <a:t>S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32980559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77</Words>
  <Application>Microsoft Office PowerPoint</Application>
  <PresentationFormat>Custom</PresentationFormat>
  <Paragraphs>7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US</dc:creator>
  <cp:lastModifiedBy>0011687</cp:lastModifiedBy>
  <cp:revision>4</cp:revision>
  <dcterms:created xsi:type="dcterms:W3CDTF">2017-03-08T13:21:10Z</dcterms:created>
  <dcterms:modified xsi:type="dcterms:W3CDTF">2017-06-28T06:59:03Z</dcterms:modified>
</cp:coreProperties>
</file>